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12" r:id="rId2"/>
  </p:sldIdLst>
  <p:sldSz cx="7559675" cy="9936163"/>
  <p:notesSz cx="6802438" cy="99345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606" userDrawn="1">
          <p15:clr>
            <a:srgbClr val="A4A3A4"/>
          </p15:clr>
        </p15:guide>
        <p15:guide id="3" orient="horz" pos="4286" userDrawn="1">
          <p15:clr>
            <a:srgbClr val="A4A3A4"/>
          </p15:clr>
        </p15:guide>
        <p15:guide id="4" orient="horz" pos="5692" userDrawn="1">
          <p15:clr>
            <a:srgbClr val="A4A3A4"/>
          </p15:clr>
        </p15:guide>
        <p15:guide id="5" orient="horz" pos="930" userDrawn="1">
          <p15:clr>
            <a:srgbClr val="A4A3A4"/>
          </p15:clr>
        </p15:guide>
        <p15:guide id="7" orient="horz" pos="3515" userDrawn="1">
          <p15:clr>
            <a:srgbClr val="A4A3A4"/>
          </p15:clr>
        </p15:guide>
        <p15:guide id="8" orient="horz" pos="2608" userDrawn="1">
          <p15:clr>
            <a:srgbClr val="A4A3A4"/>
          </p15:clr>
        </p15:guide>
        <p15:guide id="9" orient="horz" pos="4649" userDrawn="1">
          <p15:clr>
            <a:srgbClr val="A4A3A4"/>
          </p15:clr>
        </p15:guide>
        <p15:guide id="11" orient="horz" pos="4762" userDrawn="1">
          <p15:clr>
            <a:srgbClr val="A4A3A4"/>
          </p15:clr>
        </p15:guide>
        <p15:guide id="12" pos="4694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腫瘍内科 近畿大学医学部" initials="腫近" lastIdx="1" clrIdx="0">
    <p:extLst>
      <p:ext uri="{19B8F6BF-5375-455C-9EA6-DF929625EA0E}">
        <p15:presenceInfo xmlns:p15="http://schemas.microsoft.com/office/powerpoint/2012/main" userId="b406ef13a87962d3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82B4C"/>
    <a:srgbClr val="CCECFF"/>
    <a:srgbClr val="61FFA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テーマ スタイル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8D230F3-CF80-4859-8CE7-A43EE81993B5}" styleName="淡色スタイル 1 - アクセント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E8B1032C-EA38-4F05-BA0D-38AFFFC7BED3}" styleName="淡色スタイル 3 - アクセント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0660B408-B3CF-4A94-85FC-2B1E0A45F4A2}" styleName="濃色スタイル 2 - アクセント 1/アクセント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202B0CA-FC54-4496-8BCA-5EF66A818D29}" styleName="スタイル (濃色)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6327"/>
  </p:normalViewPr>
  <p:slideViewPr>
    <p:cSldViewPr snapToGrid="0" snapToObjects="1" showGuides="1">
      <p:cViewPr varScale="1">
        <p:scale>
          <a:sx n="79" d="100"/>
          <a:sy n="79" d="100"/>
        </p:scale>
        <p:origin x="2970" y="96"/>
      </p:cViewPr>
      <p:guideLst>
        <p:guide pos="3606"/>
        <p:guide orient="horz" pos="4286"/>
        <p:guide orient="horz" pos="5692"/>
        <p:guide orient="horz" pos="930"/>
        <p:guide orient="horz" pos="3515"/>
        <p:guide orient="horz" pos="2608"/>
        <p:guide orient="horz" pos="4649"/>
        <p:guide orient="horz" pos="4762"/>
        <p:guide pos="469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7512" cy="498236"/>
          </a:xfrm>
          <a:prstGeom prst="rect">
            <a:avLst/>
          </a:prstGeom>
        </p:spPr>
        <p:txBody>
          <a:bodyPr vert="horz" lIns="91374" tIns="45688" rIns="91374" bIns="45688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3342" y="1"/>
            <a:ext cx="2947512" cy="498236"/>
          </a:xfrm>
          <a:prstGeom prst="rect">
            <a:avLst/>
          </a:prstGeom>
        </p:spPr>
        <p:txBody>
          <a:bodyPr vert="horz" lIns="91374" tIns="45688" rIns="91374" bIns="45688" rtlCol="0"/>
          <a:lstStyle>
            <a:lvl1pPr algn="r">
              <a:defRPr sz="1200"/>
            </a:lvl1pPr>
          </a:lstStyle>
          <a:p>
            <a:fld id="{6F465158-8CF6-4271-801C-4DF7DC969FD4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27250" y="1243013"/>
            <a:ext cx="2547938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374" tIns="45688" rIns="91374" bIns="45688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562" y="4780846"/>
            <a:ext cx="5441316" cy="3911312"/>
          </a:xfrm>
          <a:prstGeom prst="rect">
            <a:avLst/>
          </a:prstGeom>
        </p:spPr>
        <p:txBody>
          <a:bodyPr vert="horz" lIns="91374" tIns="45688" rIns="91374" bIns="45688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36340"/>
            <a:ext cx="2947512" cy="498236"/>
          </a:xfrm>
          <a:prstGeom prst="rect">
            <a:avLst/>
          </a:prstGeom>
        </p:spPr>
        <p:txBody>
          <a:bodyPr vert="horz" lIns="91374" tIns="45688" rIns="91374" bIns="45688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3342" y="9436340"/>
            <a:ext cx="2947512" cy="498236"/>
          </a:xfrm>
          <a:prstGeom prst="rect">
            <a:avLst/>
          </a:prstGeom>
        </p:spPr>
        <p:txBody>
          <a:bodyPr vert="horz" lIns="91374" tIns="45688" rIns="91374" bIns="45688" rtlCol="0" anchor="b"/>
          <a:lstStyle>
            <a:lvl1pPr algn="r">
              <a:defRPr sz="1200"/>
            </a:lvl1pPr>
          </a:lstStyle>
          <a:p>
            <a:fld id="{2D556CFF-E290-41EC-82C8-7E6D0EEA4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43467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626127"/>
            <a:ext cx="6425724" cy="3459257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218786"/>
            <a:ext cx="5669756" cy="239893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55733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52575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29009"/>
            <a:ext cx="1630055" cy="842043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29009"/>
            <a:ext cx="4795669" cy="842043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88019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13790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477144"/>
            <a:ext cx="6520220" cy="4133167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6649412"/>
            <a:ext cx="6520220" cy="2173535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04188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645043"/>
            <a:ext cx="3212862" cy="630440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645043"/>
            <a:ext cx="3212862" cy="630440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01299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29011"/>
            <a:ext cx="6520220" cy="192053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435741"/>
            <a:ext cx="3198096" cy="1193719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629460"/>
            <a:ext cx="3198096" cy="53383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435741"/>
            <a:ext cx="3213847" cy="1193719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629460"/>
            <a:ext cx="3213847" cy="53383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38839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07134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13775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62411"/>
            <a:ext cx="2438192" cy="2318438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430626"/>
            <a:ext cx="3827085" cy="7061116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2980849"/>
            <a:ext cx="2438192" cy="5522391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8418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62411"/>
            <a:ext cx="2438192" cy="2318438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430626"/>
            <a:ext cx="3827085" cy="7061116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2980849"/>
            <a:ext cx="2438192" cy="5522391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97762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29011"/>
            <a:ext cx="6520220" cy="192053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645043"/>
            <a:ext cx="6520220" cy="63044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209353"/>
            <a:ext cx="1700927" cy="529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209353"/>
            <a:ext cx="2551390" cy="529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209353"/>
            <a:ext cx="1700927" cy="529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6605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kumimoji="1"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318A386B-6EB4-33BF-42E7-4CA35ACE1651}"/>
              </a:ext>
            </a:extLst>
          </p:cNvPr>
          <p:cNvSpPr txBox="1"/>
          <p:nvPr/>
        </p:nvSpPr>
        <p:spPr>
          <a:xfrm>
            <a:off x="145268" y="118393"/>
            <a:ext cx="6832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Figure S6.</a:t>
            </a:r>
            <a:endParaRPr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955FED8-B46F-7BE8-09B5-6D275B157A46}"/>
              </a:ext>
            </a:extLst>
          </p:cNvPr>
          <p:cNvSpPr txBox="1"/>
          <p:nvPr/>
        </p:nvSpPr>
        <p:spPr>
          <a:xfrm>
            <a:off x="414466" y="8092288"/>
            <a:ext cx="6749921" cy="66101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0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6. Potential genes associated with EMT. </a:t>
            </a:r>
            <a:r>
              <a:rPr lang="en-US" altLang="ja-JP" sz="10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 heatmap of potential genes associated with EMT in three clones of H1975Cont and H1975dnMCAK cells. EMT, epithelial-mesenchymal transition</a:t>
            </a:r>
            <a:r>
              <a:rPr lang="en-US" altLang="ja-JP" sz="1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endParaRPr lang="en-US" altLang="ja-JP" sz="10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E34D4D15-02A2-A027-2C23-B40A4C498DFD}"/>
              </a:ext>
            </a:extLst>
          </p:cNvPr>
          <p:cNvGrpSpPr/>
          <p:nvPr/>
        </p:nvGrpSpPr>
        <p:grpSpPr>
          <a:xfrm>
            <a:off x="3772602" y="5948508"/>
            <a:ext cx="904728" cy="642747"/>
            <a:chOff x="2680826" y="7664553"/>
            <a:chExt cx="904728" cy="642747"/>
          </a:xfrm>
        </p:grpSpPr>
        <p:pic>
          <p:nvPicPr>
            <p:cNvPr id="7" name="図 6">
              <a:extLst>
                <a:ext uri="{FF2B5EF4-FFF2-40B4-BE49-F238E27FC236}">
                  <a16:creationId xmlns:a16="http://schemas.microsoft.com/office/drawing/2014/main" id="{5EDEEDE7-CF15-C6C0-2B75-076133D5AF3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781811" y="7907375"/>
              <a:ext cx="752475" cy="190500"/>
            </a:xfrm>
            <a:prstGeom prst="rect">
              <a:avLst/>
            </a:prstGeom>
          </p:spPr>
        </p:pic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C1455FCA-A1A6-9FE2-2F54-BAC6BC0565BD}"/>
                </a:ext>
              </a:extLst>
            </p:cNvPr>
            <p:cNvSpPr txBox="1"/>
            <p:nvPr/>
          </p:nvSpPr>
          <p:spPr>
            <a:xfrm>
              <a:off x="2680826" y="8054983"/>
              <a:ext cx="2984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-3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E3B71BCF-BCC7-2184-BC68-326F7E937974}"/>
                </a:ext>
              </a:extLst>
            </p:cNvPr>
            <p:cNvSpPr txBox="1"/>
            <p:nvPr/>
          </p:nvSpPr>
          <p:spPr>
            <a:xfrm>
              <a:off x="3013362" y="8061079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FCF8DD46-4C07-6DB6-E193-A0FC762FB3E3}"/>
                </a:ext>
              </a:extLst>
            </p:cNvPr>
            <p:cNvSpPr txBox="1"/>
            <p:nvPr/>
          </p:nvSpPr>
          <p:spPr>
            <a:xfrm>
              <a:off x="3330355" y="8061079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4B96E9B4-6867-4FD0-90AA-56E680AFD2BF}"/>
                </a:ext>
              </a:extLst>
            </p:cNvPr>
            <p:cNvSpPr txBox="1"/>
            <p:nvPr/>
          </p:nvSpPr>
          <p:spPr>
            <a:xfrm>
              <a:off x="2782813" y="7664553"/>
              <a:ext cx="6046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z-score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3E2BF67D-DEA2-0167-3394-295836CADB84}"/>
              </a:ext>
            </a:extLst>
          </p:cNvPr>
          <p:cNvGrpSpPr/>
          <p:nvPr/>
        </p:nvGrpSpPr>
        <p:grpSpPr>
          <a:xfrm>
            <a:off x="3498189" y="2138957"/>
            <a:ext cx="1293656" cy="424811"/>
            <a:chOff x="3062840" y="99620"/>
            <a:chExt cx="1293656" cy="424811"/>
          </a:xfrm>
        </p:grpSpPr>
        <p:sp>
          <p:nvSpPr>
            <p:cNvPr id="21" name="TextBox 12">
              <a:extLst>
                <a:ext uri="{FF2B5EF4-FFF2-40B4-BE49-F238E27FC236}">
                  <a16:creationId xmlns:a16="http://schemas.microsoft.com/office/drawing/2014/main" id="{F8907476-DCD9-1F0C-5819-73C5574F9B16}"/>
                </a:ext>
              </a:extLst>
            </p:cNvPr>
            <p:cNvSpPr txBox="1"/>
            <p:nvPr/>
          </p:nvSpPr>
          <p:spPr>
            <a:xfrm>
              <a:off x="3062840" y="99620"/>
              <a:ext cx="646201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H1975</a:t>
              </a:r>
            </a:p>
            <a:p>
              <a:pPr algn="ctr"/>
              <a:r>
                <a:rPr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Cont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12">
              <a:extLst>
                <a:ext uri="{FF2B5EF4-FFF2-40B4-BE49-F238E27FC236}">
                  <a16:creationId xmlns:a16="http://schemas.microsoft.com/office/drawing/2014/main" id="{8F8EDD55-939B-FF97-3685-32965356289C}"/>
                </a:ext>
              </a:extLst>
            </p:cNvPr>
            <p:cNvSpPr txBox="1"/>
            <p:nvPr/>
          </p:nvSpPr>
          <p:spPr>
            <a:xfrm>
              <a:off x="3618855" y="105716"/>
              <a:ext cx="737641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H1975</a:t>
              </a:r>
            </a:p>
            <a:p>
              <a:pPr algn="ctr"/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dnMCAK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" name="直線コネクタ 22">
              <a:extLst>
                <a:ext uri="{FF2B5EF4-FFF2-40B4-BE49-F238E27FC236}">
                  <a16:creationId xmlns:a16="http://schemas.microsoft.com/office/drawing/2014/main" id="{11C98B35-999C-71C4-F55C-C533AE1FE75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67028" y="524430"/>
              <a:ext cx="430265" cy="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" name="直線コネクタ 23">
              <a:extLst>
                <a:ext uri="{FF2B5EF4-FFF2-40B4-BE49-F238E27FC236}">
                  <a16:creationId xmlns:a16="http://schemas.microsoft.com/office/drawing/2014/main" id="{9A754864-9A3C-A0C1-74C1-6CC4059F7CA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773247" y="524430"/>
              <a:ext cx="430265" cy="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2" name="図 1">
            <a:extLst>
              <a:ext uri="{FF2B5EF4-FFF2-40B4-BE49-F238E27FC236}">
                <a16:creationId xmlns:a16="http://schemas.microsoft.com/office/drawing/2014/main" id="{97B9427F-0643-8D35-F9D8-CE6F6BE795A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27337" y="2610529"/>
            <a:ext cx="1905000" cy="26098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097491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196</TotalTime>
  <Words>42</Words>
  <Application>Microsoft Office PowerPoint</Application>
  <PresentationFormat>ユーザー設定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鈴木慎一郎</dc:creator>
  <cp:lastModifiedBy>仁雄 米阪</cp:lastModifiedBy>
  <cp:revision>635</cp:revision>
  <cp:lastPrinted>2024-06-06T11:43:21Z</cp:lastPrinted>
  <dcterms:created xsi:type="dcterms:W3CDTF">2021-02-12T07:53:00Z</dcterms:created>
  <dcterms:modified xsi:type="dcterms:W3CDTF">2024-12-16T00:46:48Z</dcterms:modified>
</cp:coreProperties>
</file>